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6" d="100"/>
          <a:sy n="106" d="100"/>
        </p:scale>
        <p:origin x="-177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183E69-B20E-4545-945F-DA07EC549544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0EC01F-A517-1F44-8B52-E372A4BE128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92495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97B1C9-33A3-7640-AD27-E84189490CDE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881102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40707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36933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28449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2791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15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11173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5408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6252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70996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2076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3975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C9D77B-1FF4-AC43-9719-575EAAF72FF7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2FD7C8-8BD9-3943-818B-F3281C69AAF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75597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7" name="Object 3"/>
          <p:cNvGraphicFramePr>
            <a:graphicFrameLocks noChangeAspect="1"/>
          </p:cNvGraphicFramePr>
          <p:nvPr/>
        </p:nvGraphicFramePr>
        <p:xfrm>
          <a:off x="2441482" y="1344706"/>
          <a:ext cx="4010025" cy="2667000"/>
        </p:xfrm>
        <a:graphic>
          <a:graphicData uri="http://schemas.openxmlformats.org/presentationml/2006/ole">
            <p:oleObj spid="_x0000_s1027" name="Prism Project" r:id="rId4" imgW="4010123" imgH="2667060" progId="Prism4.Document">
              <p:embed/>
            </p:oleObj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31058" y="4131995"/>
            <a:ext cx="811988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Additional file 3.  </a:t>
            </a:r>
            <a:r>
              <a:rPr lang="en-US" dirty="0" smtClean="0"/>
              <a:t>MCF7 cells were cultured in a 10 cm dish and treated with or without 100 </a:t>
            </a:r>
            <a:r>
              <a:rPr lang="en-US" dirty="0" smtClean="0"/>
              <a:t>µM DHA </a:t>
            </a:r>
            <a:r>
              <a:rPr lang="en-US" dirty="0" smtClean="0"/>
              <a:t>for 24 h. The isolated </a:t>
            </a:r>
            <a:r>
              <a:rPr lang="en-US" dirty="0" err="1" smtClean="0"/>
              <a:t>exosomes</a:t>
            </a:r>
            <a:r>
              <a:rPr lang="en-US" dirty="0" smtClean="0"/>
              <a:t> were applied to EA.hy926 (1x106) cells  for 24 h. RNA </a:t>
            </a:r>
            <a:r>
              <a:rPr lang="en-US" dirty="0" smtClean="0"/>
              <a:t>was extracted </a:t>
            </a:r>
            <a:r>
              <a:rPr lang="en-US" dirty="0" smtClean="0"/>
              <a:t>from the EA.hy926 cells and let-7a, miR-23b, miR-320b, and RNU6B (endogenous </a:t>
            </a:r>
            <a:r>
              <a:rPr lang="en-US" dirty="0" smtClean="0"/>
              <a:t>control) expression </a:t>
            </a:r>
            <a:r>
              <a:rPr lang="en-US" dirty="0" smtClean="0"/>
              <a:t>was measured by  </a:t>
            </a:r>
            <a:r>
              <a:rPr lang="en-US" dirty="0" err="1" smtClean="0"/>
              <a:t>qRT</a:t>
            </a:r>
            <a:r>
              <a:rPr lang="en-US" dirty="0" smtClean="0"/>
              <a:t>-PCR. The fold change in expression levels was calculated in </a:t>
            </a:r>
            <a:r>
              <a:rPr lang="en-US" dirty="0" smtClean="0"/>
              <a:t>Excel using </a:t>
            </a:r>
            <a:r>
              <a:rPr lang="en-US" dirty="0" smtClean="0"/>
              <a:t>the Delta-Delta CT Method. Data in bar graphs represent mean + SEM (n=6). 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522093" y="537882"/>
            <a:ext cx="17764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Additional file </a:t>
            </a:r>
            <a:r>
              <a:rPr lang="en-US" dirty="0" smtClean="0"/>
              <a:t>3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274413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97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GraphPad Prism 4 Project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thany</dc:creator>
  <cp:lastModifiedBy>wding</cp:lastModifiedBy>
  <cp:revision>4</cp:revision>
  <dcterms:created xsi:type="dcterms:W3CDTF">2015-05-29T17:45:19Z</dcterms:created>
  <dcterms:modified xsi:type="dcterms:W3CDTF">2015-05-29T22:02:57Z</dcterms:modified>
</cp:coreProperties>
</file>